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78" r:id="rId3"/>
    <p:sldId id="265" r:id="rId4"/>
    <p:sldId id="263" r:id="rId5"/>
    <p:sldId id="279" r:id="rId6"/>
    <p:sldId id="257" r:id="rId7"/>
    <p:sldId id="280" r:id="rId8"/>
    <p:sldId id="281" r:id="rId9"/>
    <p:sldId id="282" r:id="rId10"/>
    <p:sldId id="262" r:id="rId11"/>
    <p:sldId id="264" r:id="rId12"/>
    <p:sldId id="277" r:id="rId1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6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316" y="32"/>
      </p:cViewPr>
      <p:guideLst>
        <p:guide orient="horz" pos="2136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636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692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969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066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335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034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826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259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916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9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651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7B1FB-85C2-4B14-80D9-CD9F630D9F25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3ACD62-8BA7-4472-83F9-83612B7C1B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046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7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png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3" Type="http://schemas.openxmlformats.org/officeDocument/2006/relationships/image" Target="../media/image73.png"/><Relationship Id="rId7" Type="http://schemas.openxmlformats.org/officeDocument/2006/relationships/image" Target="../media/image77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6.png"/><Relationship Id="rId5" Type="http://schemas.openxmlformats.org/officeDocument/2006/relationships/image" Target="../media/image75.png"/><Relationship Id="rId4" Type="http://schemas.openxmlformats.org/officeDocument/2006/relationships/image" Target="../media/image74.png"/><Relationship Id="rId9" Type="http://schemas.openxmlformats.org/officeDocument/2006/relationships/image" Target="../media/image7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3" Type="http://schemas.openxmlformats.org/officeDocument/2006/relationships/image" Target="../media/image49.png"/><Relationship Id="rId7" Type="http://schemas.openxmlformats.org/officeDocument/2006/relationships/image" Target="../media/image53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089767-439B-4584-B662-F49EFBD9AA2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data</a:t>
            </a:r>
          </a:p>
        </p:txBody>
      </p:sp>
    </p:spTree>
    <p:extLst>
      <p:ext uri="{BB962C8B-B14F-4D97-AF65-F5344CB8AC3E}">
        <p14:creationId xmlns:p14="http://schemas.microsoft.com/office/powerpoint/2010/main" val="29503956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11B7DEC-3F46-44CD-A165-66BF58223D09}"/>
              </a:ext>
            </a:extLst>
          </p:cNvPr>
          <p:cNvSpPr txBox="1"/>
          <p:nvPr/>
        </p:nvSpPr>
        <p:spPr>
          <a:xfrm>
            <a:off x="934323" y="2370337"/>
            <a:ext cx="5298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FB98538-773A-46D6-BA9D-63203EBA6BFD}"/>
              </a:ext>
            </a:extLst>
          </p:cNvPr>
          <p:cNvSpPr txBox="1"/>
          <p:nvPr/>
        </p:nvSpPr>
        <p:spPr>
          <a:xfrm>
            <a:off x="934323" y="4264105"/>
            <a:ext cx="5298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2138A60-158C-4938-8112-DD1FA2BBBB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5434" y="194540"/>
            <a:ext cx="3045647" cy="204412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CBB79A4-6877-4C0C-B821-94912E69CD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3834" y="2238667"/>
            <a:ext cx="2982211" cy="217579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2F6CDD1-1004-4A04-8A08-57FACC87CC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62115" y="4612988"/>
            <a:ext cx="3045647" cy="197769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13A5398-9F6E-4FC3-8AA6-4EFFD698FF46}"/>
              </a:ext>
            </a:extLst>
          </p:cNvPr>
          <p:cNvSpPr txBox="1"/>
          <p:nvPr/>
        </p:nvSpPr>
        <p:spPr>
          <a:xfrm>
            <a:off x="863943" y="113430"/>
            <a:ext cx="5298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A</a:t>
            </a:r>
          </a:p>
        </p:txBody>
      </p:sp>
    </p:spTree>
    <p:extLst>
      <p:ext uri="{BB962C8B-B14F-4D97-AF65-F5344CB8AC3E}">
        <p14:creationId xmlns:p14="http://schemas.microsoft.com/office/powerpoint/2010/main" val="390172695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16337C5-1140-4320-8EAB-FA7C26BE20A8}"/>
              </a:ext>
            </a:extLst>
          </p:cNvPr>
          <p:cNvSpPr txBox="1"/>
          <p:nvPr/>
        </p:nvSpPr>
        <p:spPr>
          <a:xfrm>
            <a:off x="498668" y="194540"/>
            <a:ext cx="566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A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38BC6EC-AD92-427A-B8B9-01B2BDC8FE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818" y="194540"/>
            <a:ext cx="3185565" cy="230173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DBC4AEE-12D4-438D-8DA0-2A678BFE67C7}"/>
              </a:ext>
            </a:extLst>
          </p:cNvPr>
          <p:cNvSpPr txBox="1"/>
          <p:nvPr/>
        </p:nvSpPr>
        <p:spPr>
          <a:xfrm>
            <a:off x="4288674" y="194539"/>
            <a:ext cx="389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B71140D-5655-4898-8AEF-2F810140E57A}"/>
              </a:ext>
            </a:extLst>
          </p:cNvPr>
          <p:cNvSpPr txBox="1"/>
          <p:nvPr/>
        </p:nvSpPr>
        <p:spPr>
          <a:xfrm>
            <a:off x="526061" y="2814931"/>
            <a:ext cx="389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D754DF3-A174-46B9-93E2-6565525D4C5D}"/>
              </a:ext>
            </a:extLst>
          </p:cNvPr>
          <p:cNvSpPr txBox="1"/>
          <p:nvPr/>
        </p:nvSpPr>
        <p:spPr>
          <a:xfrm>
            <a:off x="4377070" y="2735033"/>
            <a:ext cx="389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A6A5A3C-267C-409A-93A5-6011DDFE5A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8533" y="230922"/>
            <a:ext cx="3373514" cy="226535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B5968C3-6C1F-4531-ABDC-044744D18D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5320" y="2496276"/>
            <a:ext cx="2942237" cy="212375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E77C320-24B4-4C91-9204-BBC02919D0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66481" y="2538457"/>
            <a:ext cx="3185566" cy="220467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C377B5F-96A2-4D83-977B-66979CF626FF}"/>
              </a:ext>
            </a:extLst>
          </p:cNvPr>
          <p:cNvSpPr txBox="1"/>
          <p:nvPr/>
        </p:nvSpPr>
        <p:spPr>
          <a:xfrm>
            <a:off x="526060" y="4813888"/>
            <a:ext cx="389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1BD9434-894A-433E-A4E4-6153980E3D5A}"/>
              </a:ext>
            </a:extLst>
          </p:cNvPr>
          <p:cNvSpPr txBox="1"/>
          <p:nvPr/>
        </p:nvSpPr>
        <p:spPr>
          <a:xfrm>
            <a:off x="4377069" y="4728993"/>
            <a:ext cx="389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BD3134C-A77E-4ABC-BC14-1DCC8C90BD7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33563" y="4620028"/>
            <a:ext cx="3047820" cy="212451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B3C05FB-E48F-4754-8CEB-A4B62E01F0D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07711" y="4620028"/>
            <a:ext cx="3044336" cy="22046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62264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8A27BA8-B9D1-4E80-AF45-CC0E473048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0705" y="451789"/>
            <a:ext cx="1772899" cy="191473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67B0B95-B717-4FD4-87FC-BE67C53363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3604" y="535989"/>
            <a:ext cx="1864311" cy="175847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2071D76-AB39-4A98-B476-217C98AEEC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87915" y="451789"/>
            <a:ext cx="1864311" cy="196418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D3F9F8C-BA29-4A37-88A0-AF3416ED8DA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28703" y="535989"/>
            <a:ext cx="1929876" cy="198022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AD0FC33-4E78-41A7-BC5F-D1CCF37F34E3}"/>
              </a:ext>
            </a:extLst>
          </p:cNvPr>
          <p:cNvSpPr txBox="1"/>
          <p:nvPr/>
        </p:nvSpPr>
        <p:spPr>
          <a:xfrm>
            <a:off x="357876" y="176786"/>
            <a:ext cx="6275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A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AE5627-E8AA-4C3E-9F24-F357631E67F7}"/>
              </a:ext>
            </a:extLst>
          </p:cNvPr>
          <p:cNvSpPr txBox="1"/>
          <p:nvPr/>
        </p:nvSpPr>
        <p:spPr>
          <a:xfrm>
            <a:off x="357876" y="2366520"/>
            <a:ext cx="378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CDF31BE-1435-4922-B246-6533F27ACDB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2268" y="2885752"/>
            <a:ext cx="1891338" cy="200786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149A9D6-EB98-4A41-AD87-D65BAFD093C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76501" y="2885752"/>
            <a:ext cx="1864311" cy="198294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AFB645B-0DC6-4315-9073-AA2D0B9EB9B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00694" y="2947896"/>
            <a:ext cx="1936863" cy="183263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030D6D1-46D9-4334-A97C-B3A33612687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397439" y="2895140"/>
            <a:ext cx="1936863" cy="1962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5366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21FF550-1B56-4E1E-B14E-0A0C1FDD16BC}"/>
              </a:ext>
            </a:extLst>
          </p:cNvPr>
          <p:cNvSpPr txBox="1"/>
          <p:nvPr/>
        </p:nvSpPr>
        <p:spPr>
          <a:xfrm>
            <a:off x="201181" y="369573"/>
            <a:ext cx="441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A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4354828-1A53-45B0-B008-6EA0DC1A9E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8758" y="86090"/>
            <a:ext cx="4024263" cy="238003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A6E8466-50DC-4165-B56E-E4CCC26F51A8}"/>
              </a:ext>
            </a:extLst>
          </p:cNvPr>
          <p:cNvSpPr txBox="1"/>
          <p:nvPr/>
        </p:nvSpPr>
        <p:spPr>
          <a:xfrm>
            <a:off x="6048702" y="100763"/>
            <a:ext cx="745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ive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3E631F6-83F4-4EB9-8761-EF91DF8231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42183" y="508072"/>
            <a:ext cx="1722925" cy="175018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8E02094-1DAB-4EE5-A150-BFC27CF034CE}"/>
              </a:ext>
            </a:extLst>
          </p:cNvPr>
          <p:cNvSpPr txBox="1"/>
          <p:nvPr/>
        </p:nvSpPr>
        <p:spPr>
          <a:xfrm>
            <a:off x="329771" y="4139296"/>
            <a:ext cx="441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82C5EDB5-C6F4-457D-9DE1-554E657136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6695" y="4277795"/>
            <a:ext cx="2138097" cy="210599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A4BC9AF-0C59-43E9-98BF-0585FDD8FE4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52177" y="4042248"/>
            <a:ext cx="2208274" cy="239284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36F2E20-3B94-4570-BAC1-9A7C0302FA3F}"/>
              </a:ext>
            </a:extLst>
          </p:cNvPr>
          <p:cNvSpPr txBox="1"/>
          <p:nvPr/>
        </p:nvSpPr>
        <p:spPr>
          <a:xfrm>
            <a:off x="2846154" y="4123920"/>
            <a:ext cx="441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FB0B12-D412-4350-B0A5-16F72B19313B}"/>
              </a:ext>
            </a:extLst>
          </p:cNvPr>
          <p:cNvSpPr txBox="1"/>
          <p:nvPr/>
        </p:nvSpPr>
        <p:spPr>
          <a:xfrm>
            <a:off x="5362537" y="4139295"/>
            <a:ext cx="441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8051EE3E-5C2E-4712-843A-CDAB120B338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32921" y="4178671"/>
            <a:ext cx="2064374" cy="2120000"/>
          </a:xfrm>
          <a:prstGeom prst="rect">
            <a:avLst/>
          </a:prstGeom>
        </p:spPr>
      </p:pic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F5F7CEA9-CB3D-4210-B054-847089EFE404}"/>
              </a:ext>
            </a:extLst>
          </p:cNvPr>
          <p:cNvCxnSpPr/>
          <p:nvPr/>
        </p:nvCxnSpPr>
        <p:spPr>
          <a:xfrm>
            <a:off x="4554247" y="1020931"/>
            <a:ext cx="56817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Picture 28">
            <a:extLst>
              <a:ext uri="{FF2B5EF4-FFF2-40B4-BE49-F238E27FC236}">
                <a16:creationId xmlns:a16="http://schemas.microsoft.com/office/drawing/2014/main" id="{B209F917-181F-4E32-909D-F82BBAC2CE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66474" y="2362441"/>
            <a:ext cx="3381375" cy="178117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5246438A-0FD3-4408-95DF-017CC6C36940}"/>
              </a:ext>
            </a:extLst>
          </p:cNvPr>
          <p:cNvSpPr txBox="1"/>
          <p:nvPr/>
        </p:nvSpPr>
        <p:spPr>
          <a:xfrm>
            <a:off x="4616813" y="2920527"/>
            <a:ext cx="745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ive</a:t>
            </a:r>
          </a:p>
        </p:txBody>
      </p:sp>
    </p:spTree>
    <p:extLst>
      <p:ext uri="{BB962C8B-B14F-4D97-AF65-F5344CB8AC3E}">
        <p14:creationId xmlns:p14="http://schemas.microsoft.com/office/powerpoint/2010/main" val="2424140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37DE7318-6D08-4256-82F2-8F9ABA1055DA}"/>
              </a:ext>
            </a:extLst>
          </p:cNvPr>
          <p:cNvGrpSpPr/>
          <p:nvPr/>
        </p:nvGrpSpPr>
        <p:grpSpPr>
          <a:xfrm>
            <a:off x="6970" y="52494"/>
            <a:ext cx="8385900" cy="6823234"/>
            <a:chOff x="6970" y="52494"/>
            <a:chExt cx="8385900" cy="6823234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91759440-6F5E-41F7-A89F-3E35F6D3395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65135" y="5191012"/>
              <a:ext cx="1584779" cy="1614494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3CD582F2-31BE-42E4-88B8-879C978220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57146" y="5265678"/>
              <a:ext cx="1376493" cy="1610050"/>
            </a:xfrm>
            <a:prstGeom prst="rect">
              <a:avLst/>
            </a:prstGeom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6798C382-8B7A-4D7A-8C16-097A84F507AF}"/>
                </a:ext>
              </a:extLst>
            </p:cNvPr>
            <p:cNvGrpSpPr/>
            <p:nvPr/>
          </p:nvGrpSpPr>
          <p:grpSpPr>
            <a:xfrm>
              <a:off x="6970" y="52494"/>
              <a:ext cx="8385900" cy="5336898"/>
              <a:chOff x="6970" y="52494"/>
              <a:chExt cx="8385900" cy="5336898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B481B47E-DF83-438B-988D-95B83A3C8752}"/>
                  </a:ext>
                </a:extLst>
              </p:cNvPr>
              <p:cNvSpPr txBox="1"/>
              <p:nvPr/>
            </p:nvSpPr>
            <p:spPr>
              <a:xfrm>
                <a:off x="6970" y="52494"/>
                <a:ext cx="5009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A. 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4F787FA-047D-4919-AE54-40E03A1DDE80}"/>
                  </a:ext>
                </a:extLst>
              </p:cNvPr>
              <p:cNvSpPr txBox="1"/>
              <p:nvPr/>
            </p:nvSpPr>
            <p:spPr>
              <a:xfrm>
                <a:off x="2743200" y="52494"/>
                <a:ext cx="5681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P1</a:t>
                </a:r>
              </a:p>
            </p:txBody>
          </p: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id="{4D4B432A-9056-46ED-9B8B-C36860088C5C}"/>
                  </a:ext>
                </a:extLst>
              </p:cNvPr>
              <p:cNvCxnSpPr/>
              <p:nvPr/>
            </p:nvCxnSpPr>
            <p:spPr>
              <a:xfrm>
                <a:off x="1455938" y="1289352"/>
                <a:ext cx="53773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23BE4055-A6D8-48AD-8C6E-1BDFE1535331}"/>
                  </a:ext>
                </a:extLst>
              </p:cNvPr>
              <p:cNvSpPr txBox="1"/>
              <p:nvPr/>
            </p:nvSpPr>
            <p:spPr>
              <a:xfrm>
                <a:off x="324633" y="3715708"/>
                <a:ext cx="7812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D4 + </a:t>
                </a:r>
              </a:p>
            </p:txBody>
          </p: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2BADEABC-21EC-4FD5-BC1C-7D27F00DA84A}"/>
                  </a:ext>
                </a:extLst>
              </p:cNvPr>
              <p:cNvGrpSpPr/>
              <p:nvPr/>
            </p:nvGrpSpPr>
            <p:grpSpPr>
              <a:xfrm>
                <a:off x="257452" y="329493"/>
                <a:ext cx="1635793" cy="1656241"/>
                <a:chOff x="257452" y="453784"/>
                <a:chExt cx="1635793" cy="1656241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F76C9859-E5BC-435A-B742-064F6947161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57452" y="453784"/>
                  <a:ext cx="1635793" cy="1656241"/>
                </a:xfrm>
                <a:prstGeom prst="rect">
                  <a:avLst/>
                </a:prstGeom>
              </p:spPr>
            </p:pic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C2F833E2-546C-4134-A1A4-87354869B2F1}"/>
                    </a:ext>
                  </a:extLst>
                </p:cNvPr>
                <p:cNvSpPr txBox="1"/>
                <p:nvPr/>
              </p:nvSpPr>
              <p:spPr>
                <a:xfrm>
                  <a:off x="1287529" y="683969"/>
                  <a:ext cx="56817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P1</a:t>
                  </a:r>
                </a:p>
              </p:txBody>
            </p:sp>
          </p:grpSp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02F6C8A5-59C7-4FEC-956F-7323BB7B6D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993669" y="325313"/>
                <a:ext cx="1797096" cy="1786431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362FA77E-1598-458F-B342-B8118DADF6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979900" y="2076403"/>
                <a:ext cx="1586269" cy="1639305"/>
              </a:xfrm>
              <a:prstGeom prst="rect">
                <a:avLst/>
              </a:prstGeom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CAE9679C-9E41-4489-ADCB-7B0987096F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566169" y="2076403"/>
                <a:ext cx="1359426" cy="1552939"/>
              </a:xfrm>
              <a:prstGeom prst="rect">
                <a:avLst/>
              </a:prstGeom>
            </p:spPr>
          </p:pic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FE08EC82-CE3A-4A11-97EA-712801A968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960446" y="2034936"/>
                <a:ext cx="1616196" cy="1636336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B51C0798-46A9-4E38-80C4-36D50F2967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611493" y="2016043"/>
                <a:ext cx="1515555" cy="1642699"/>
              </a:xfrm>
              <a:prstGeom prst="rect">
                <a:avLst/>
              </a:prstGeom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40FE0AD8-89D7-4FC0-B876-8F75C902C7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984598" y="3629342"/>
                <a:ext cx="1586269" cy="1671337"/>
              </a:xfrm>
              <a:prstGeom prst="rect">
                <a:avLst/>
              </a:prstGeom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484318D7-A8B7-477B-9BF6-D1D9B5E5F3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549914" y="3671272"/>
                <a:ext cx="1483725" cy="1614494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96FFE55D-D7D8-4880-A558-DFA48FE9F2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5477715" y="3792196"/>
                <a:ext cx="2915155" cy="1037253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5F485698-D58E-409E-A1F0-21AD9CB75EA0}"/>
                  </a:ext>
                </a:extLst>
              </p:cNvPr>
              <p:cNvSpPr txBox="1"/>
              <p:nvPr/>
            </p:nvSpPr>
            <p:spPr>
              <a:xfrm>
                <a:off x="1569319" y="2060116"/>
                <a:ext cx="5009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. 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B3370D8-CFA4-445E-ABC7-2C1519575A41}"/>
                  </a:ext>
                </a:extLst>
              </p:cNvPr>
              <p:cNvSpPr txBox="1"/>
              <p:nvPr/>
            </p:nvSpPr>
            <p:spPr>
              <a:xfrm>
                <a:off x="1680501" y="5081615"/>
                <a:ext cx="5009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. 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07876C05-BC17-4C37-8243-EF6A914A0F79}"/>
                  </a:ext>
                </a:extLst>
              </p:cNvPr>
              <p:cNvSpPr txBox="1"/>
              <p:nvPr/>
            </p:nvSpPr>
            <p:spPr>
              <a:xfrm>
                <a:off x="1552757" y="3467812"/>
                <a:ext cx="5009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. </a:t>
                </a:r>
              </a:p>
            </p:txBody>
          </p:sp>
          <p:cxnSp>
            <p:nvCxnSpPr>
              <p:cNvPr id="7" name="Straight Arrow Connector 6">
                <a:extLst>
                  <a:ext uri="{FF2B5EF4-FFF2-40B4-BE49-F238E27FC236}">
                    <a16:creationId xmlns:a16="http://schemas.microsoft.com/office/drawing/2014/main" id="{0145C6DB-231E-463A-A5D0-9A3D3F050CB1}"/>
                  </a:ext>
                </a:extLst>
              </p:cNvPr>
              <p:cNvCxnSpPr/>
              <p:nvPr/>
            </p:nvCxnSpPr>
            <p:spPr>
              <a:xfrm>
                <a:off x="1105868" y="3906175"/>
                <a:ext cx="2196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4914298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6913E7C-BD49-4A90-BCFB-6CB94941DB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0031" y="299714"/>
            <a:ext cx="1836660" cy="208455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9600915-B244-4B96-92A1-717B6ACF52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0009" y="2619724"/>
            <a:ext cx="1612129" cy="211483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2FE0431-81F6-4AFC-9665-929668BB10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92037" y="2872900"/>
            <a:ext cx="1148040" cy="80424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67CEB9A-9094-476F-B146-0F5445396DDF}"/>
              </a:ext>
            </a:extLst>
          </p:cNvPr>
          <p:cNvSpPr txBox="1"/>
          <p:nvPr/>
        </p:nvSpPr>
        <p:spPr>
          <a:xfrm>
            <a:off x="350897" y="145825"/>
            <a:ext cx="545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A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382EDD9-31EA-48FD-B221-A67E19216A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3138" y="453602"/>
            <a:ext cx="1900099" cy="1871310"/>
          </a:xfrm>
          <a:prstGeom prst="rect">
            <a:avLst/>
          </a:prstGeom>
        </p:spPr>
      </p:pic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5B2C1116-ED7C-4E57-96A1-08F66715A9C6}"/>
              </a:ext>
            </a:extLst>
          </p:cNvPr>
          <p:cNvCxnSpPr/>
          <p:nvPr/>
        </p:nvCxnSpPr>
        <p:spPr>
          <a:xfrm>
            <a:off x="2139518" y="1215253"/>
            <a:ext cx="3018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3A12FE4-56CE-46E3-AFE7-F35D37F095B7}"/>
              </a:ext>
            </a:extLst>
          </p:cNvPr>
          <p:cNvCxnSpPr/>
          <p:nvPr/>
        </p:nvCxnSpPr>
        <p:spPr>
          <a:xfrm>
            <a:off x="4369293" y="1189112"/>
            <a:ext cx="3018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149013C4-D6A9-4231-BB1B-78C968A549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86546" y="237090"/>
            <a:ext cx="1905000" cy="22098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BD0FB1C7-7421-402D-98A8-14A0DB18FD4F}"/>
              </a:ext>
            </a:extLst>
          </p:cNvPr>
          <p:cNvSpPr txBox="1"/>
          <p:nvPr/>
        </p:nvSpPr>
        <p:spPr>
          <a:xfrm>
            <a:off x="254261" y="2611835"/>
            <a:ext cx="5457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B.</a:t>
            </a:r>
          </a:p>
        </p:txBody>
      </p:sp>
    </p:spTree>
    <p:extLst>
      <p:ext uri="{BB962C8B-B14F-4D97-AF65-F5344CB8AC3E}">
        <p14:creationId xmlns:p14="http://schemas.microsoft.com/office/powerpoint/2010/main" val="24106858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1E61264-CB84-4555-9EE9-1193F91EFEA3}"/>
              </a:ext>
            </a:extLst>
          </p:cNvPr>
          <p:cNvSpPr txBox="1"/>
          <p:nvPr/>
        </p:nvSpPr>
        <p:spPr>
          <a:xfrm>
            <a:off x="0" y="105508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FF5F63C-35DD-42DD-A244-A24C3C39621B}"/>
              </a:ext>
            </a:extLst>
          </p:cNvPr>
          <p:cNvSpPr txBox="1"/>
          <p:nvPr/>
        </p:nvSpPr>
        <p:spPr>
          <a:xfrm>
            <a:off x="0" y="2151463"/>
            <a:ext cx="750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67EE48-BA33-4AF8-97B1-D0FAA6BEBEC6}"/>
              </a:ext>
            </a:extLst>
          </p:cNvPr>
          <p:cNvSpPr txBox="1"/>
          <p:nvPr/>
        </p:nvSpPr>
        <p:spPr>
          <a:xfrm>
            <a:off x="-23449" y="3886708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EFF853C-B15B-47D9-B1CA-A324C4E04126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5137" y="259395"/>
            <a:ext cx="2227385" cy="1885927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EE41B03-E290-43E9-B037-1A64B059E86F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2522" y="259396"/>
            <a:ext cx="2227385" cy="2004646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Content Placeholder 3">
            <a:extLst>
              <a:ext uri="{FF2B5EF4-FFF2-40B4-BE49-F238E27FC236}">
                <a16:creationId xmlns:a16="http://schemas.microsoft.com/office/drawing/2014/main" id="{2DCBF377-E3C3-4EBC-BD8A-69EBB2FE5F1B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4923693" y="413284"/>
            <a:ext cx="1559170" cy="173203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9F33EB2-B8F3-430F-9E1F-975311549E68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2459240"/>
            <a:ext cx="2345448" cy="1837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408561E-0E26-4A93-8995-0F8F4C176558}"/>
              </a:ext>
            </a:extLst>
          </p:cNvPr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4048" y="2507622"/>
            <a:ext cx="2227384" cy="1885927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92E4A20-F69B-4AC8-BA5D-CC9A916A007B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>
          <a:xfrm>
            <a:off x="4923693" y="2507622"/>
            <a:ext cx="1559170" cy="188592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780B1A4-4434-4DF7-8418-4A5DE6486C06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4469700"/>
            <a:ext cx="2345448" cy="183754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E24F279-A682-4B71-82B3-38E3495508EF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4048" y="4504870"/>
            <a:ext cx="2227383" cy="1837544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A340A4E-3704-4751-9216-B11A9D427554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>
          <a:xfrm>
            <a:off x="4919496" y="4469700"/>
            <a:ext cx="1559170" cy="183754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1203615-6FC3-499A-915E-D5AFFA30AD35}"/>
              </a:ext>
            </a:extLst>
          </p:cNvPr>
          <p:cNvPicPr/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1729" y="3162902"/>
            <a:ext cx="1166446" cy="103158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9891075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F1AB5A5-E5C9-4E3F-9DC0-BD08F49BF742}"/>
              </a:ext>
            </a:extLst>
          </p:cNvPr>
          <p:cNvSpPr txBox="1"/>
          <p:nvPr/>
        </p:nvSpPr>
        <p:spPr>
          <a:xfrm>
            <a:off x="322365" y="-28555"/>
            <a:ext cx="441109" cy="2852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A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DE326A1-BC73-407A-BBD0-3E1F572F6B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2086" y="216737"/>
            <a:ext cx="1965401" cy="201438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3FB5038-1262-4D0B-A477-F322C40283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70820" y="256690"/>
            <a:ext cx="1965401" cy="191657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C02B00F-357C-4927-A021-0A350989B3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46189" y="216737"/>
            <a:ext cx="1965401" cy="200949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D0051C1-11F7-4274-BBEA-F6FFC388F1E8}"/>
              </a:ext>
            </a:extLst>
          </p:cNvPr>
          <p:cNvSpPr txBox="1"/>
          <p:nvPr/>
        </p:nvSpPr>
        <p:spPr>
          <a:xfrm>
            <a:off x="460977" y="2557480"/>
            <a:ext cx="441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EE75034-31A2-47B5-9769-FA15864B56A2}"/>
              </a:ext>
            </a:extLst>
          </p:cNvPr>
          <p:cNvSpPr txBox="1"/>
          <p:nvPr/>
        </p:nvSpPr>
        <p:spPr>
          <a:xfrm>
            <a:off x="460976" y="4511324"/>
            <a:ext cx="441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41CC0BB-661E-4AE9-845C-1034909EAD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2086" y="2358843"/>
            <a:ext cx="1965401" cy="202475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2928990-861A-4482-B443-C0ABC19234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88276" y="2358177"/>
            <a:ext cx="2047945" cy="200818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31476EF-7C1F-4326-A952-20FCC130F7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46189" y="2332485"/>
            <a:ext cx="1965401" cy="202597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7A683EE-AF3A-4ECD-881A-F506E3C4BF0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8986" y="4597186"/>
            <a:ext cx="2068502" cy="206257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CBB609B-8F4A-400D-B947-C5A60838FA5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32562" y="4603721"/>
            <a:ext cx="2113628" cy="212675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E119A92-1F72-4E1B-BDAE-4E035A9EC2A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46189" y="4603721"/>
            <a:ext cx="2119892" cy="2056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24392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A96E7C7-1D04-493F-9AD0-388966E3EC13}"/>
              </a:ext>
            </a:extLst>
          </p:cNvPr>
          <p:cNvSpPr txBox="1"/>
          <p:nvPr/>
        </p:nvSpPr>
        <p:spPr>
          <a:xfrm>
            <a:off x="1118586" y="78875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A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B48B634-7C18-4696-A0EE-7C7E154076F1}"/>
              </a:ext>
            </a:extLst>
          </p:cNvPr>
          <p:cNvSpPr txBox="1"/>
          <p:nvPr/>
        </p:nvSpPr>
        <p:spPr>
          <a:xfrm>
            <a:off x="1118586" y="2231365"/>
            <a:ext cx="7502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6274752-05DD-4709-B855-AD728120D4E0}"/>
              </a:ext>
            </a:extLst>
          </p:cNvPr>
          <p:cNvSpPr txBox="1"/>
          <p:nvPr/>
        </p:nvSpPr>
        <p:spPr>
          <a:xfrm>
            <a:off x="1095137" y="4552535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D7AA7C6-0B8D-46E8-AE9B-BB16FDA6BFA0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1678" y="386652"/>
            <a:ext cx="3112476" cy="1685146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DB172FF-69C9-430D-91C7-8C078A8697E6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5511" y="386652"/>
            <a:ext cx="3112475" cy="1685146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0CEA407-BCDE-4414-8514-A047E9542018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1677" y="2656036"/>
            <a:ext cx="3112475" cy="1685146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67C1395-38A0-4F3D-95C8-D4599E839594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9951" y="4788147"/>
            <a:ext cx="3112474" cy="1449534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629808C-4806-4D0E-84EC-E994297477F9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5511" y="4706423"/>
            <a:ext cx="3112474" cy="16851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2B621C3-09D4-49E5-AE37-438A8E5D7E70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4339" y="2656037"/>
            <a:ext cx="3217984" cy="168514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4135748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24F3570-7F06-4D0F-B804-2B81DAF2103E}"/>
              </a:ext>
            </a:extLst>
          </p:cNvPr>
          <p:cNvSpPr txBox="1"/>
          <p:nvPr/>
        </p:nvSpPr>
        <p:spPr>
          <a:xfrm>
            <a:off x="1740025" y="105509"/>
            <a:ext cx="532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A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2209298-1DA3-4355-B507-FF9698B294CF}"/>
              </a:ext>
            </a:extLst>
          </p:cNvPr>
          <p:cNvSpPr txBox="1"/>
          <p:nvPr/>
        </p:nvSpPr>
        <p:spPr>
          <a:xfrm>
            <a:off x="1740026" y="1437617"/>
            <a:ext cx="634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EF346FE-82D9-4CDE-9231-335C694F9A92}"/>
              </a:ext>
            </a:extLst>
          </p:cNvPr>
          <p:cNvSpPr txBox="1"/>
          <p:nvPr/>
        </p:nvSpPr>
        <p:spPr>
          <a:xfrm>
            <a:off x="1740025" y="3006561"/>
            <a:ext cx="386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C0C3EB7-EBE2-411D-BED8-B1F77CA3A0F3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3776" y="259396"/>
            <a:ext cx="2457115" cy="1214776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6AF7E51-DAE5-4DF1-A87F-32A8CA8E88F8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4940" y="294341"/>
            <a:ext cx="2684989" cy="121477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5D34873-9316-4F11-9228-AD446E8A5528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4828" y="1745393"/>
            <a:ext cx="2457115" cy="1314645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1531C98-A6DC-48FD-8698-CD27031C8E73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8512" y="1845263"/>
            <a:ext cx="2377844" cy="1214775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D057F2B-E869-4859-BB32-3A99966E7B90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4828" y="3314337"/>
            <a:ext cx="2457114" cy="124878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9B433E3-8D02-47B5-9F86-5573B4DE3845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0451" y="3314337"/>
            <a:ext cx="2377844" cy="1248785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309DF6C-68AA-46C3-AF02-8646C5D54BC2}"/>
              </a:ext>
            </a:extLst>
          </p:cNvPr>
          <p:cNvSpPr txBox="1"/>
          <p:nvPr/>
        </p:nvSpPr>
        <p:spPr>
          <a:xfrm>
            <a:off x="1759489" y="4708395"/>
            <a:ext cx="3864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54E92A3-C041-4F25-A522-60EE5AACB40E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2685" y="5016172"/>
            <a:ext cx="2100436" cy="111800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2094165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998C687-BDAD-47A9-96EA-D09B91A628F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1718" y="290933"/>
            <a:ext cx="2203829" cy="1385742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34F9D51-DF6A-44B4-8456-DE126AAD0A95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8157" y="268190"/>
            <a:ext cx="1924065" cy="1385742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D97E4FF-7F27-42EE-A965-116D126BA6D4}"/>
              </a:ext>
            </a:extLst>
          </p:cNvPr>
          <p:cNvSpPr txBox="1"/>
          <p:nvPr/>
        </p:nvSpPr>
        <p:spPr>
          <a:xfrm>
            <a:off x="1642369" y="105509"/>
            <a:ext cx="509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A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646B9E-AFD5-43A0-A669-8A9E11CC54EA}"/>
              </a:ext>
            </a:extLst>
          </p:cNvPr>
          <p:cNvSpPr txBox="1"/>
          <p:nvPr/>
        </p:nvSpPr>
        <p:spPr>
          <a:xfrm>
            <a:off x="1782024" y="1553856"/>
            <a:ext cx="6477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4EC305-0BD7-42D6-84B0-2BFF4C20F60B}"/>
              </a:ext>
            </a:extLst>
          </p:cNvPr>
          <p:cNvSpPr txBox="1"/>
          <p:nvPr/>
        </p:nvSpPr>
        <p:spPr>
          <a:xfrm>
            <a:off x="1782024" y="3170519"/>
            <a:ext cx="3947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F5F0A6-F960-4A23-93ED-E05578507623}"/>
              </a:ext>
            </a:extLst>
          </p:cNvPr>
          <p:cNvSpPr txBox="1"/>
          <p:nvPr/>
        </p:nvSpPr>
        <p:spPr>
          <a:xfrm>
            <a:off x="1782024" y="5003211"/>
            <a:ext cx="3947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98E2992-8C5B-4FED-9896-9691B3752056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0480" y="1590512"/>
            <a:ext cx="2203829" cy="1517142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19FC8ED-FB01-4E74-B95C-D7037F76FBA6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0156" y="1794250"/>
            <a:ext cx="2005034" cy="1336233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71930DF-B022-4E1B-8493-04FD23CFF340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0480" y="3324406"/>
            <a:ext cx="2203829" cy="14573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0949A00-63D1-44A6-9655-4AEC24213917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0155" y="3359575"/>
            <a:ext cx="2096125" cy="1336232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81B2856-2C20-4B42-AB66-B49682B1B9D0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7162" y="4849321"/>
            <a:ext cx="2549464" cy="1735907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6032B2B-5FA5-4D10-912E-28A4D9436D89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1896" y="4849322"/>
            <a:ext cx="2315583" cy="163805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150235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9</TotalTime>
  <Words>82</Words>
  <Application>Microsoft Office PowerPoint</Application>
  <PresentationFormat>On-screen Show (4:3)</PresentationFormat>
  <Paragraphs>44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Supplementary dat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ra</dc:creator>
  <cp:lastModifiedBy>Barbara Osborne</cp:lastModifiedBy>
  <cp:revision>47</cp:revision>
  <dcterms:created xsi:type="dcterms:W3CDTF">2020-02-27T22:18:23Z</dcterms:created>
  <dcterms:modified xsi:type="dcterms:W3CDTF">2020-04-28T03:29:20Z</dcterms:modified>
</cp:coreProperties>
</file>